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159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327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966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550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2968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455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072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350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124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039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925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CEA79-6050-49E3-A776-32BB9948502E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18E64-1E16-4308-A8C5-5FF46ADC8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908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4042" y="586321"/>
            <a:ext cx="10367094" cy="5493636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202267" y="5851357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31</a:t>
            </a: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 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orrelation between β-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nd 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for acridines against resistant strain FCR3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66020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8:48Z</dcterms:created>
  <dcterms:modified xsi:type="dcterms:W3CDTF">2020-08-04T16:38:11Z</dcterms:modified>
</cp:coreProperties>
</file>